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6" r:id="rId2"/>
    <p:sldId id="298" r:id="rId3"/>
    <p:sldId id="302" r:id="rId4"/>
    <p:sldId id="304" r:id="rId5"/>
    <p:sldId id="303" r:id="rId6"/>
    <p:sldId id="299" r:id="rId7"/>
    <p:sldId id="301" r:id="rId8"/>
    <p:sldId id="300" r:id="rId9"/>
    <p:sldId id="305" r:id="rId10"/>
  </p:sldIdLst>
  <p:sldSz cx="6858000" cy="9144000" type="screen4x3"/>
  <p:notesSz cx="6877050" cy="10001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1" userDrawn="1">
          <p15:clr>
            <a:srgbClr val="A4A3A4"/>
          </p15:clr>
        </p15:guide>
        <p15:guide id="2" orient="horz" pos="2358" userDrawn="1">
          <p15:clr>
            <a:srgbClr val="A4A3A4"/>
          </p15:clr>
        </p15:guide>
        <p15:guide id="3" orient="horz" pos="272" userDrawn="1">
          <p15:clr>
            <a:srgbClr val="A4A3A4"/>
          </p15:clr>
        </p15:guide>
        <p15:guide id="4" orient="horz" pos="1655" userDrawn="1">
          <p15:clr>
            <a:srgbClr val="A4A3A4"/>
          </p15:clr>
        </p15:guide>
        <p15:guide id="5" orient="horz" pos="226" userDrawn="1">
          <p15:clr>
            <a:srgbClr val="A4A3A4"/>
          </p15:clr>
        </p15:guide>
        <p15:guide id="6" orient="horz" pos="2835" userDrawn="1">
          <p15:clr>
            <a:srgbClr val="A4A3A4"/>
          </p15:clr>
        </p15:guide>
        <p15:guide id="7" orient="horz" pos="4241" userDrawn="1">
          <p15:clr>
            <a:srgbClr val="A4A3A4"/>
          </p15:clr>
        </p15:guide>
        <p15:guide id="8" orient="horz" pos="3243" userDrawn="1">
          <p15:clr>
            <a:srgbClr val="A4A3A4"/>
          </p15:clr>
        </p15:guide>
        <p15:guide id="9" orient="horz" pos="2585" userDrawn="1">
          <p15:clr>
            <a:srgbClr val="A4A3A4"/>
          </p15:clr>
        </p15:guide>
        <p15:guide id="10" orient="horz" pos="2109" userDrawn="1">
          <p15:clr>
            <a:srgbClr val="A4A3A4"/>
          </p15:clr>
        </p15:guide>
        <p15:guide id="11" orient="horz" pos="453" userDrawn="1">
          <p15:clr>
            <a:srgbClr val="A4A3A4"/>
          </p15:clr>
        </p15:guide>
        <p15:guide id="12" orient="horz" pos="962">
          <p15:clr>
            <a:srgbClr val="A4A3A4"/>
          </p15:clr>
        </p15:guide>
        <p15:guide id="13" orient="horz" pos="1292" userDrawn="1">
          <p15:clr>
            <a:srgbClr val="A4A3A4"/>
          </p15:clr>
        </p15:guide>
        <p15:guide id="14" orient="horz" pos="3016" userDrawn="1">
          <p15:clr>
            <a:srgbClr val="A4A3A4"/>
          </p15:clr>
        </p15:guide>
        <p15:guide id="15" orient="horz" pos="1247" userDrawn="1">
          <p15:clr>
            <a:srgbClr val="A4A3A4"/>
          </p15:clr>
        </p15:guide>
        <p15:guide id="16" orient="horz" pos="1497" userDrawn="1">
          <p15:clr>
            <a:srgbClr val="A4A3A4"/>
          </p15:clr>
        </p15:guide>
        <p15:guide id="17" orient="horz" pos="4445" userDrawn="1">
          <p15:clr>
            <a:srgbClr val="A4A3A4"/>
          </p15:clr>
        </p15:guide>
        <p15:guide id="18" orient="horz" pos="2313" userDrawn="1">
          <p15:clr>
            <a:srgbClr val="A4A3A4"/>
          </p15:clr>
        </p15:guide>
        <p15:guide id="19" orient="horz" pos="2461">
          <p15:clr>
            <a:srgbClr val="A4A3A4"/>
          </p15:clr>
        </p15:guide>
        <p15:guide id="20" orient="horz" pos="4655">
          <p15:clr>
            <a:srgbClr val="A4A3A4"/>
          </p15:clr>
        </p15:guide>
        <p15:guide id="21" orient="horz" pos="2880" userDrawn="1">
          <p15:clr>
            <a:srgbClr val="A4A3A4"/>
          </p15:clr>
        </p15:guide>
        <p15:guide id="23" pos="2319" userDrawn="1">
          <p15:clr>
            <a:srgbClr val="A4A3A4"/>
          </p15:clr>
        </p15:guide>
        <p15:guide id="24" pos="822" userDrawn="1">
          <p15:clr>
            <a:srgbClr val="A4A3A4"/>
          </p15:clr>
        </p15:guide>
        <p15:guide id="25" pos="135">
          <p15:clr>
            <a:srgbClr val="A4A3A4"/>
          </p15:clr>
        </p15:guide>
        <p15:guide id="26" pos="200">
          <p15:clr>
            <a:srgbClr val="A4A3A4"/>
          </p15:clr>
        </p15:guide>
        <p15:guide id="27" pos="1282">
          <p15:clr>
            <a:srgbClr val="A4A3A4"/>
          </p15:clr>
        </p15:guide>
        <p15:guide id="28" pos="2523" userDrawn="1">
          <p15:clr>
            <a:srgbClr val="A4A3A4"/>
          </p15:clr>
        </p15:guide>
        <p15:guide id="29" pos="1530">
          <p15:clr>
            <a:srgbClr val="A4A3A4"/>
          </p15:clr>
        </p15:guide>
        <p15:guide id="30" pos="1621">
          <p15:clr>
            <a:srgbClr val="A4A3A4"/>
          </p15:clr>
        </p15:guide>
        <p15:guide id="31" pos="1661" userDrawn="1">
          <p15:clr>
            <a:srgbClr val="A4A3A4"/>
          </p15:clr>
        </p15:guide>
        <p15:guide id="32" pos="55">
          <p15:clr>
            <a:srgbClr val="A4A3A4"/>
          </p15:clr>
        </p15:guide>
        <p15:guide id="33" orient="horz" pos="555">
          <p15:clr>
            <a:srgbClr val="A4A3A4"/>
          </p15:clr>
        </p15:guide>
        <p15:guide id="34" orient="horz" pos="235">
          <p15:clr>
            <a:srgbClr val="A4A3A4"/>
          </p15:clr>
        </p15:guide>
        <p15:guide id="35" orient="horz" pos="281">
          <p15:clr>
            <a:srgbClr val="A4A3A4"/>
          </p15:clr>
        </p15:guide>
        <p15:guide id="36" orient="horz" pos="1489">
          <p15:clr>
            <a:srgbClr val="A4A3A4"/>
          </p15:clr>
        </p15:guide>
        <p15:guide id="37" pos="1187">
          <p15:clr>
            <a:srgbClr val="A4A3A4"/>
          </p15:clr>
        </p15:guide>
        <p15:guide id="38" pos="1384">
          <p15:clr>
            <a:srgbClr val="A4A3A4"/>
          </p15:clr>
        </p15:guide>
        <p15:guide id="39" orient="horz" pos="340" userDrawn="1">
          <p15:clr>
            <a:srgbClr val="A4A3A4"/>
          </p15:clr>
        </p15:guide>
        <p15:guide id="40" orient="horz" pos="1014">
          <p15:clr>
            <a:srgbClr val="A4A3A4"/>
          </p15:clr>
        </p15:guide>
        <p15:guide id="41" orient="horz" pos="1723" userDrawn="1">
          <p15:clr>
            <a:srgbClr val="A4A3A4"/>
          </p15:clr>
        </p15:guide>
        <p15:guide id="42" orient="horz" pos="1111" userDrawn="1">
          <p15:clr>
            <a:srgbClr val="A4A3A4"/>
          </p15:clr>
        </p15:guide>
        <p15:guide id="43" orient="horz" pos="2751">
          <p15:clr>
            <a:srgbClr val="A4A3A4"/>
          </p15:clr>
        </p15:guide>
        <p15:guide id="44" orient="horz" pos="458">
          <p15:clr>
            <a:srgbClr val="A4A3A4"/>
          </p15:clr>
        </p15:guide>
        <p15:guide id="45" orient="horz" pos="363" userDrawn="1">
          <p15:clr>
            <a:srgbClr val="A4A3A4"/>
          </p15:clr>
        </p15:guide>
        <p15:guide id="46" pos="436" userDrawn="1">
          <p15:clr>
            <a:srgbClr val="A4A3A4"/>
          </p15:clr>
        </p15:guide>
        <p15:guide id="47" pos="570">
          <p15:clr>
            <a:srgbClr val="A4A3A4"/>
          </p15:clr>
        </p15:guide>
        <p15:guide id="48" pos="1487">
          <p15:clr>
            <a:srgbClr val="A4A3A4"/>
          </p15:clr>
        </p15:guide>
        <p15:guide id="49" pos="156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Yu Jin Kim" initials="YJK" lastIdx="1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3F3C"/>
    <a:srgbClr val="97BAE5"/>
    <a:srgbClr val="2A7286"/>
    <a:srgbClr val="235F6F"/>
    <a:srgbClr val="007A37"/>
    <a:srgbClr val="005828"/>
    <a:srgbClr val="6C6CE6"/>
    <a:srgbClr val="7373E7"/>
    <a:srgbClr val="7878E8"/>
    <a:srgbClr val="6565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9770" autoAdjust="0"/>
  </p:normalViewPr>
  <p:slideViewPr>
    <p:cSldViewPr snapToGrid="0">
      <p:cViewPr varScale="1">
        <p:scale>
          <a:sx n="88" d="100"/>
          <a:sy n="88" d="100"/>
        </p:scale>
        <p:origin x="2886" y="90"/>
      </p:cViewPr>
      <p:guideLst>
        <p:guide orient="horz" pos="2631"/>
        <p:guide orient="horz" pos="2358"/>
        <p:guide orient="horz" pos="272"/>
        <p:guide orient="horz" pos="1655"/>
        <p:guide orient="horz" pos="226"/>
        <p:guide orient="horz" pos="2835"/>
        <p:guide orient="horz" pos="4241"/>
        <p:guide orient="horz" pos="3243"/>
        <p:guide orient="horz" pos="2585"/>
        <p:guide orient="horz" pos="2109"/>
        <p:guide orient="horz" pos="453"/>
        <p:guide orient="horz" pos="962"/>
        <p:guide orient="horz" pos="1292"/>
        <p:guide orient="horz" pos="3016"/>
        <p:guide orient="horz" pos="1247"/>
        <p:guide orient="horz" pos="1497"/>
        <p:guide orient="horz" pos="4445"/>
        <p:guide orient="horz" pos="2313"/>
        <p:guide orient="horz" pos="2461"/>
        <p:guide orient="horz" pos="4655"/>
        <p:guide orient="horz" pos="2880"/>
        <p:guide pos="2319"/>
        <p:guide pos="822"/>
        <p:guide pos="135"/>
        <p:guide pos="200"/>
        <p:guide pos="1282"/>
        <p:guide pos="2523"/>
        <p:guide pos="1530"/>
        <p:guide pos="1621"/>
        <p:guide pos="1661"/>
        <p:guide pos="55"/>
        <p:guide orient="horz" pos="555"/>
        <p:guide orient="horz" pos="235"/>
        <p:guide orient="horz" pos="281"/>
        <p:guide orient="horz" pos="1489"/>
        <p:guide pos="1187"/>
        <p:guide pos="1384"/>
        <p:guide orient="horz" pos="340"/>
        <p:guide orient="horz" pos="1014"/>
        <p:guide orient="horz" pos="1723"/>
        <p:guide orient="horz" pos="1111"/>
        <p:guide orient="horz" pos="2751"/>
        <p:guide orient="horz" pos="458"/>
        <p:guide orient="horz" pos="363"/>
        <p:guide pos="436"/>
        <p:guide pos="570"/>
        <p:guide pos="1487"/>
        <p:guide pos="156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95725" y="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BDE4A1-3B6A-4146-A83B-F64710FDD727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32000" y="750888"/>
            <a:ext cx="28130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7388" y="4751388"/>
            <a:ext cx="5502275" cy="45005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960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95725" y="949960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8E996C-6EFC-41C0-8227-04410D3094B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8602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2709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2709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1981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33087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78019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2709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246552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27091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2000" y="750888"/>
            <a:ext cx="2813050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208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D6B92-039F-448A-B9D7-E2F2FC6047BE}" type="datetimeFigureOut">
              <a:rPr lang="ko-KR" altLang="en-US" smtClean="0"/>
              <a:pPr/>
              <a:t>2019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 rot="16200000">
            <a:off x="-195673" y="903792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(% BMSC)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472" y="230715"/>
            <a:ext cx="2520000" cy="1610248"/>
          </a:xfrm>
          <a:prstGeom prst="rect">
            <a:avLst/>
          </a:prstGeom>
        </p:spPr>
      </p:pic>
      <p:sp>
        <p:nvSpPr>
          <p:cNvPr id="36" name="직사각형 35"/>
          <p:cNvSpPr/>
          <p:nvPr/>
        </p:nvSpPr>
        <p:spPr>
          <a:xfrm>
            <a:off x="768321" y="1709698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2H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직사각형 36"/>
          <p:cNvSpPr/>
          <p:nvPr/>
        </p:nvSpPr>
        <p:spPr>
          <a:xfrm>
            <a:off x="999382" y="1709698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5H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547768" y="1709698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BMSC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>
            <a:off x="809554" y="1922250"/>
            <a:ext cx="86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28267" y="1881162"/>
            <a:ext cx="13811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NANOG</a:t>
            </a:r>
            <a:endParaRPr lang="ko-KR" altLang="en-US" sz="6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직사각형 40"/>
          <p:cNvSpPr/>
          <p:nvPr/>
        </p:nvSpPr>
        <p:spPr>
          <a:xfrm>
            <a:off x="1173727" y="1752373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LIPO</a:t>
            </a:r>
          </a:p>
          <a:p>
            <a:r>
              <a:rPr lang="en-US" altLang="ko-KR" sz="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1407814" y="1708480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직사각형 42"/>
          <p:cNvSpPr/>
          <p:nvPr/>
        </p:nvSpPr>
        <p:spPr>
          <a:xfrm>
            <a:off x="1842438" y="1708481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2H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직사각형 43"/>
          <p:cNvSpPr/>
          <p:nvPr/>
        </p:nvSpPr>
        <p:spPr>
          <a:xfrm>
            <a:off x="2073499" y="1708481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5H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1621885" y="1708481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BMSC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>
            <a:off x="1883671" y="1921033"/>
            <a:ext cx="86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602384" y="1879945"/>
            <a:ext cx="1381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OCT-4</a:t>
            </a:r>
            <a:endParaRPr lang="ko-KR" altLang="en-US" sz="800" b="1" i="1" dirty="0">
              <a:latin typeface="Arial" pitchFamily="34" charset="0"/>
              <a:cs typeface="Arial" pitchFamily="34" charset="0"/>
            </a:endParaRPr>
          </a:p>
          <a:p>
            <a:pPr algn="ctr"/>
            <a:endParaRPr lang="ko-KR" altLang="en-US" sz="6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직사각형 47"/>
          <p:cNvSpPr/>
          <p:nvPr/>
        </p:nvSpPr>
        <p:spPr>
          <a:xfrm>
            <a:off x="2247844" y="1751156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LIPO</a:t>
            </a:r>
          </a:p>
          <a:p>
            <a:r>
              <a:rPr lang="en-US" altLang="ko-KR" sz="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2481931" y="1707263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-215890" y="975463"/>
            <a:ext cx="15853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  0           100         200         300        400 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 Figure 1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2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2948659"/>
              </p:ext>
            </p:extLst>
          </p:nvPr>
        </p:nvGraphicFramePr>
        <p:xfrm>
          <a:off x="2794000" y="444500"/>
          <a:ext cx="289560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93750"/>
                <a:gridCol w="1041400"/>
                <a:gridCol w="1060450"/>
              </a:tblGrid>
              <a:tr h="3175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over </a:t>
                      </a:r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cZ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2/HPRT1</a:t>
                      </a:r>
                      <a:r>
                        <a:rPr lang="en-US" altLang="ko-KR" sz="600" i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 expression 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over LIPO-863B of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2/HPRT1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RNA expression 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LacZ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MDM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CDK4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MDM2&amp;CDK4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PO-863B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7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6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.7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62" name="표 16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786831"/>
              </p:ext>
            </p:extLst>
          </p:nvPr>
        </p:nvGraphicFramePr>
        <p:xfrm>
          <a:off x="2794000" y="2336800"/>
          <a:ext cx="289560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93750"/>
                <a:gridCol w="1041400"/>
                <a:gridCol w="1060450"/>
              </a:tblGrid>
              <a:tr h="3175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over </a:t>
                      </a:r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cZ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2/HPRT1</a:t>
                      </a:r>
                      <a:r>
                        <a:rPr lang="en-US" altLang="ko-KR" sz="600" i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 expression 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over LIPO-863B of 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6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2/HPRT1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RNA expression 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LacZ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MDM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CDK4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CDK4&amp;MDM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PO-863B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6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98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6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3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</a:t>
                      </a:r>
                      <a:endParaRPr lang="ko-KR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70" name="그림 6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03" t="59625" r="5244" b="2734"/>
          <a:stretch/>
        </p:blipFill>
        <p:spPr>
          <a:xfrm>
            <a:off x="815524" y="459607"/>
            <a:ext cx="1740826" cy="1365237"/>
          </a:xfrm>
          <a:prstGeom prst="rect">
            <a:avLst/>
          </a:prstGeom>
        </p:spPr>
      </p:pic>
      <p:sp>
        <p:nvSpPr>
          <p:cNvPr id="72" name="직사각형 71"/>
          <p:cNvSpPr/>
          <p:nvPr/>
        </p:nvSpPr>
        <p:spPr>
          <a:xfrm>
            <a:off x="1076679" y="175348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직사각형 73"/>
          <p:cNvSpPr/>
          <p:nvPr/>
        </p:nvSpPr>
        <p:spPr>
          <a:xfrm>
            <a:off x="1365278" y="175348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직사각형 74"/>
          <p:cNvSpPr/>
          <p:nvPr/>
        </p:nvSpPr>
        <p:spPr>
          <a:xfrm>
            <a:off x="783923" y="175348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acZ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1884411" y="180125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IPO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직사각형 76"/>
          <p:cNvSpPr/>
          <p:nvPr/>
        </p:nvSpPr>
        <p:spPr>
          <a:xfrm>
            <a:off x="2138952" y="174728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1620459" y="180125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DM2&amp;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6200000">
            <a:off x="-184191" y="851208"/>
            <a:ext cx="10441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MDM2/HPRT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(% 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LacZ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)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직사각형 79"/>
          <p:cNvSpPr/>
          <p:nvPr/>
        </p:nvSpPr>
        <p:spPr>
          <a:xfrm>
            <a:off x="452710" y="169212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직사각형 81"/>
          <p:cNvSpPr/>
          <p:nvPr/>
        </p:nvSpPr>
        <p:spPr>
          <a:xfrm>
            <a:off x="452710" y="1482321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5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직사각형 83"/>
          <p:cNvSpPr/>
          <p:nvPr/>
        </p:nvSpPr>
        <p:spPr>
          <a:xfrm>
            <a:off x="452710" y="1260650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1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직사각형 104"/>
          <p:cNvSpPr/>
          <p:nvPr/>
        </p:nvSpPr>
        <p:spPr>
          <a:xfrm>
            <a:off x="452710" y="1038973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15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직사각형 105"/>
          <p:cNvSpPr/>
          <p:nvPr/>
        </p:nvSpPr>
        <p:spPr>
          <a:xfrm>
            <a:off x="452710" y="82917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2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직사각형 106"/>
          <p:cNvSpPr/>
          <p:nvPr/>
        </p:nvSpPr>
        <p:spPr>
          <a:xfrm>
            <a:off x="452710" y="696567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4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직사각형 109"/>
          <p:cNvSpPr/>
          <p:nvPr/>
        </p:nvSpPr>
        <p:spPr>
          <a:xfrm>
            <a:off x="452710" y="563960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12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직사각형 112"/>
          <p:cNvSpPr/>
          <p:nvPr/>
        </p:nvSpPr>
        <p:spPr>
          <a:xfrm>
            <a:off x="452710" y="425411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20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964445" y="1933027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직선 연결선 114"/>
          <p:cNvCxnSpPr/>
          <p:nvPr/>
        </p:nvCxnSpPr>
        <p:spPr>
          <a:xfrm>
            <a:off x="1043281" y="1980809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오른쪽 대괄호 115"/>
          <p:cNvSpPr/>
          <p:nvPr/>
        </p:nvSpPr>
        <p:spPr>
          <a:xfrm rot="16200000">
            <a:off x="1126758" y="1014322"/>
            <a:ext cx="45719" cy="288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8" name="TextBox 117"/>
          <p:cNvSpPr txBox="1"/>
          <p:nvPr/>
        </p:nvSpPr>
        <p:spPr>
          <a:xfrm>
            <a:off x="1290811" y="711431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 </a:t>
            </a:r>
            <a:r>
              <a:rPr lang="en-US" altLang="ko-KR" sz="600" b="1" dirty="0" smtClean="0">
                <a:cs typeface="Arial" pitchFamily="34" charset="0"/>
              </a:rPr>
              <a:t>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416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오른쪽 대괄호 120"/>
          <p:cNvSpPr/>
          <p:nvPr/>
        </p:nvSpPr>
        <p:spPr>
          <a:xfrm rot="16200000">
            <a:off x="1243861" y="778938"/>
            <a:ext cx="45719" cy="504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4" name="TextBox 123"/>
          <p:cNvSpPr txBox="1"/>
          <p:nvPr/>
        </p:nvSpPr>
        <p:spPr>
          <a:xfrm>
            <a:off x="1000329" y="853410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0.204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오른쪽 대괄호 124"/>
          <p:cNvSpPr/>
          <p:nvPr/>
        </p:nvSpPr>
        <p:spPr>
          <a:xfrm rot="16200000">
            <a:off x="1537286" y="628810"/>
            <a:ext cx="45719" cy="504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7" name="오른쪽 대괄호 126"/>
          <p:cNvSpPr/>
          <p:nvPr/>
        </p:nvSpPr>
        <p:spPr>
          <a:xfrm rot="16200000">
            <a:off x="1932182" y="409058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28" name="TextBox 127"/>
          <p:cNvSpPr txBox="1"/>
          <p:nvPr/>
        </p:nvSpPr>
        <p:spPr>
          <a:xfrm>
            <a:off x="1668403" y="372503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 </a:t>
            </a:r>
            <a:r>
              <a:rPr lang="en-US" altLang="ko-KR" sz="600" b="1" dirty="0" smtClean="0">
                <a:cs typeface="Arial" pitchFamily="34" charset="0"/>
              </a:rPr>
              <a:t>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20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오른쪽 대괄호 128"/>
          <p:cNvSpPr/>
          <p:nvPr/>
        </p:nvSpPr>
        <p:spPr>
          <a:xfrm rot="16200000">
            <a:off x="2227886" y="411330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30" name="TextBox 129"/>
          <p:cNvSpPr txBox="1"/>
          <p:nvPr/>
        </p:nvSpPr>
        <p:spPr>
          <a:xfrm>
            <a:off x="1957283" y="367951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 </a:t>
            </a:r>
            <a:r>
              <a:rPr lang="en-US" altLang="ko-KR" sz="600" b="1" dirty="0" smtClean="0">
                <a:cs typeface="Arial" pitchFamily="34" charset="0"/>
              </a:rPr>
              <a:t>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20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875221" y="994444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&lt;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4" name="그림 13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3" t="6145" r="4308" b="58781"/>
          <a:stretch/>
        </p:blipFill>
        <p:spPr>
          <a:xfrm>
            <a:off x="836635" y="2363788"/>
            <a:ext cx="1800203" cy="1344068"/>
          </a:xfrm>
          <a:prstGeom prst="rect">
            <a:avLst/>
          </a:prstGeom>
        </p:spPr>
      </p:pic>
      <p:cxnSp>
        <p:nvCxnSpPr>
          <p:cNvPr id="135" name="직선 연결선 134"/>
          <p:cNvCxnSpPr/>
          <p:nvPr/>
        </p:nvCxnSpPr>
        <p:spPr>
          <a:xfrm>
            <a:off x="1043281" y="1980809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직사각형 136"/>
          <p:cNvSpPr/>
          <p:nvPr/>
        </p:nvSpPr>
        <p:spPr>
          <a:xfrm>
            <a:off x="443335" y="3566696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직사각형 137"/>
          <p:cNvSpPr/>
          <p:nvPr/>
        </p:nvSpPr>
        <p:spPr>
          <a:xfrm>
            <a:off x="443335" y="3275007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5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443335" y="297827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1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직사각형 140"/>
          <p:cNvSpPr/>
          <p:nvPr/>
        </p:nvSpPr>
        <p:spPr>
          <a:xfrm>
            <a:off x="443335" y="2688355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15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직사각형 141"/>
          <p:cNvSpPr/>
          <p:nvPr/>
        </p:nvSpPr>
        <p:spPr>
          <a:xfrm>
            <a:off x="443335" y="2591613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5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직사각형 142"/>
          <p:cNvSpPr/>
          <p:nvPr/>
        </p:nvSpPr>
        <p:spPr>
          <a:xfrm>
            <a:off x="443335" y="2445358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6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직사각형 143"/>
          <p:cNvSpPr/>
          <p:nvPr/>
        </p:nvSpPr>
        <p:spPr>
          <a:xfrm>
            <a:off x="443335" y="2306809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7000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 rot="16200000">
            <a:off x="-152620" y="2718958"/>
            <a:ext cx="10441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MDM2/HPRT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(% 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LacZ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)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045579" y="2775752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0.204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오른쪽 대괄호 147"/>
          <p:cNvSpPr/>
          <p:nvPr/>
        </p:nvSpPr>
        <p:spPr>
          <a:xfrm rot="16200000">
            <a:off x="1158559" y="2979680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9" name="TextBox 148"/>
          <p:cNvSpPr txBox="1"/>
          <p:nvPr/>
        </p:nvSpPr>
        <p:spPr>
          <a:xfrm>
            <a:off x="904547" y="2934976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&lt;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오른쪽 대괄호 149"/>
          <p:cNvSpPr/>
          <p:nvPr/>
        </p:nvSpPr>
        <p:spPr>
          <a:xfrm rot="16200000">
            <a:off x="1720399" y="2975128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1" name="TextBox 150"/>
          <p:cNvSpPr txBox="1"/>
          <p:nvPr/>
        </p:nvSpPr>
        <p:spPr>
          <a:xfrm>
            <a:off x="1336731" y="2609696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cs typeface="Arial" pitchFamily="34" charset="0"/>
              </a:rPr>
              <a:t>0.052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오른쪽 대괄호 151"/>
          <p:cNvSpPr/>
          <p:nvPr/>
        </p:nvSpPr>
        <p:spPr>
          <a:xfrm rot="16200000">
            <a:off x="1963784" y="2324576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3" name="TextBox 152"/>
          <p:cNvSpPr txBox="1"/>
          <p:nvPr/>
        </p:nvSpPr>
        <p:spPr>
          <a:xfrm>
            <a:off x="1679533" y="2281197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 </a:t>
            </a:r>
            <a:r>
              <a:rPr lang="en-US" altLang="ko-KR" sz="600" b="1" dirty="0" smtClean="0">
                <a:cs typeface="Arial" pitchFamily="34" charset="0"/>
              </a:rPr>
              <a:t> 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오른쪽 대괄호 153"/>
          <p:cNvSpPr/>
          <p:nvPr/>
        </p:nvSpPr>
        <p:spPr>
          <a:xfrm rot="16200000">
            <a:off x="2259488" y="2320024"/>
            <a:ext cx="45719" cy="25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55" name="TextBox 154"/>
          <p:cNvSpPr txBox="1"/>
          <p:nvPr/>
        </p:nvSpPr>
        <p:spPr>
          <a:xfrm>
            <a:off x="1988885" y="2276645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 </a:t>
            </a:r>
            <a:r>
              <a:rPr lang="en-US" altLang="ko-KR" sz="600" b="1" dirty="0" smtClean="0">
                <a:cs typeface="Arial" pitchFamily="34" charset="0"/>
              </a:rPr>
              <a:t>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2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직사각형 155"/>
          <p:cNvSpPr/>
          <p:nvPr/>
        </p:nvSpPr>
        <p:spPr>
          <a:xfrm>
            <a:off x="1078951" y="3632356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직사각형 156"/>
          <p:cNvSpPr/>
          <p:nvPr/>
        </p:nvSpPr>
        <p:spPr>
          <a:xfrm>
            <a:off x="1367550" y="3632356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직사각형 157"/>
          <p:cNvSpPr/>
          <p:nvPr/>
        </p:nvSpPr>
        <p:spPr>
          <a:xfrm>
            <a:off x="786195" y="3632356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acZ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직사각형 158"/>
          <p:cNvSpPr/>
          <p:nvPr/>
        </p:nvSpPr>
        <p:spPr>
          <a:xfrm>
            <a:off x="1900331" y="368012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IPO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직사각형 159"/>
          <p:cNvSpPr/>
          <p:nvPr/>
        </p:nvSpPr>
        <p:spPr>
          <a:xfrm>
            <a:off x="2161696" y="362615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직사각형 160"/>
          <p:cNvSpPr/>
          <p:nvPr/>
        </p:nvSpPr>
        <p:spPr>
          <a:xfrm>
            <a:off x="1622731" y="368012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DM2&amp;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966717" y="3822785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직선 연결선 163"/>
          <p:cNvCxnSpPr/>
          <p:nvPr/>
        </p:nvCxnSpPr>
        <p:spPr>
          <a:xfrm>
            <a:off x="1045553" y="385968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직선 연결선 164"/>
          <p:cNvCxnSpPr/>
          <p:nvPr/>
        </p:nvCxnSpPr>
        <p:spPr>
          <a:xfrm>
            <a:off x="1045553" y="385968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오른쪽 대괄호 165"/>
          <p:cNvSpPr/>
          <p:nvPr/>
        </p:nvSpPr>
        <p:spPr>
          <a:xfrm rot="16200000">
            <a:off x="1293901" y="2705578"/>
            <a:ext cx="45719" cy="504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67" name="오른쪽 대괄호 166"/>
          <p:cNvSpPr/>
          <p:nvPr/>
        </p:nvSpPr>
        <p:spPr>
          <a:xfrm rot="16200000">
            <a:off x="1582781" y="2537250"/>
            <a:ext cx="45719" cy="504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99121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3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5851907"/>
              </p:ext>
            </p:extLst>
          </p:nvPr>
        </p:nvGraphicFramePr>
        <p:xfrm>
          <a:off x="587831" y="407482"/>
          <a:ext cx="5671455" cy="177088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4291"/>
                <a:gridCol w="1134291"/>
                <a:gridCol w="1134291"/>
                <a:gridCol w="1134291"/>
                <a:gridCol w="1134291"/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LacZ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MDM2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CDK4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-MDM2&amp;CDK4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640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r>
                        <a:rPr lang="en-US" altLang="ko-KR" sz="8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(µm)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4.61±12.9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5.44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28.8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1.81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0.6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7.33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6.8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64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Diameter </a:t>
                      </a: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  <a:endParaRPr lang="ko-KR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1.26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0.8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.52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4.2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1.74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9.2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.46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0.9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64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LacZ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MDM2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CDK4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-MDM2&amp;CDK4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640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Length (µm)</a:t>
                      </a:r>
                      <a:endParaRPr lang="ko-KR" alt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8.41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5.2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9.09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3.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0.89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3.1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8.13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21.9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64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 Diameter </a:t>
                      </a:r>
                      <a:r>
                        <a:rPr lang="en-US" altLang="ko-KR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µm)</a:t>
                      </a:r>
                      <a:endParaRPr lang="ko-KR" alt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2.43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24.3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.18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6.9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9.69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0.1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.43</a:t>
                      </a:r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5.5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28" y="2256237"/>
            <a:ext cx="6749143" cy="2651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8499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4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2" t="4258" r="47438" b="70622"/>
          <a:stretch/>
        </p:blipFill>
        <p:spPr>
          <a:xfrm>
            <a:off x="504825" y="379686"/>
            <a:ext cx="2895600" cy="2296887"/>
          </a:xfrm>
          <a:prstGeom prst="rect">
            <a:avLst/>
          </a:prstGeom>
        </p:spPr>
      </p:pic>
      <p:pic>
        <p:nvPicPr>
          <p:cNvPr id="65" name="그림 6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7" t="36863" r="49847" b="37627"/>
          <a:stretch/>
        </p:blipFill>
        <p:spPr>
          <a:xfrm>
            <a:off x="514350" y="2789914"/>
            <a:ext cx="2743200" cy="2332561"/>
          </a:xfrm>
          <a:prstGeom prst="rect">
            <a:avLst/>
          </a:prstGeom>
        </p:spPr>
      </p:pic>
      <p:sp>
        <p:nvSpPr>
          <p:cNvPr id="66" name="TextBox 65"/>
          <p:cNvSpPr txBox="1"/>
          <p:nvPr/>
        </p:nvSpPr>
        <p:spPr>
          <a:xfrm rot="16200000">
            <a:off x="-219295" y="1033047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TERT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3267075" y="622300"/>
            <a:ext cx="295275" cy="13573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2800130" y="1104127"/>
            <a:ext cx="1044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E6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1" name="그림 7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48" t="4258" b="70622"/>
          <a:stretch/>
        </p:blipFill>
        <p:spPr>
          <a:xfrm>
            <a:off x="3467100" y="388382"/>
            <a:ext cx="2777288" cy="2296887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821570" y="2590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직선 연결선 82"/>
          <p:cNvCxnSpPr/>
          <p:nvPr/>
        </p:nvCxnSpPr>
        <p:spPr>
          <a:xfrm>
            <a:off x="986131" y="2628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1678820" y="2590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직선 연결선 85"/>
          <p:cNvCxnSpPr/>
          <p:nvPr/>
        </p:nvCxnSpPr>
        <p:spPr>
          <a:xfrm>
            <a:off x="1843381" y="2628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3812420" y="2590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직선 연결선 87"/>
          <p:cNvCxnSpPr/>
          <p:nvPr/>
        </p:nvCxnSpPr>
        <p:spPr>
          <a:xfrm>
            <a:off x="3976981" y="2628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4669670" y="2590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직선 연결선 89"/>
          <p:cNvCxnSpPr/>
          <p:nvPr/>
        </p:nvCxnSpPr>
        <p:spPr>
          <a:xfrm>
            <a:off x="4834231" y="2628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1" name="그림 9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58" t="69418" r="50447" b="5374"/>
          <a:stretch/>
        </p:blipFill>
        <p:spPr>
          <a:xfrm>
            <a:off x="504825" y="5215396"/>
            <a:ext cx="2705100" cy="2305050"/>
          </a:xfrm>
          <a:prstGeom prst="rect">
            <a:avLst/>
          </a:prstGeom>
        </p:spPr>
      </p:pic>
      <p:pic>
        <p:nvPicPr>
          <p:cNvPr id="92" name="그림 9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90" t="36863" b="37627"/>
          <a:stretch/>
        </p:blipFill>
        <p:spPr>
          <a:xfrm>
            <a:off x="3511888" y="2794249"/>
            <a:ext cx="2805863" cy="2332561"/>
          </a:xfrm>
          <a:prstGeom prst="rect">
            <a:avLst/>
          </a:prstGeom>
        </p:spPr>
      </p:pic>
      <p:sp>
        <p:nvSpPr>
          <p:cNvPr id="93" name="TextBox 92"/>
          <p:cNvSpPr txBox="1"/>
          <p:nvPr/>
        </p:nvSpPr>
        <p:spPr>
          <a:xfrm rot="16200000">
            <a:off x="-219295" y="3404772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E7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821570" y="49905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직선 연결선 94"/>
          <p:cNvCxnSpPr/>
          <p:nvPr/>
        </p:nvCxnSpPr>
        <p:spPr>
          <a:xfrm>
            <a:off x="986131" y="50288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1678820" y="49905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직선 연결선 96"/>
          <p:cNvCxnSpPr/>
          <p:nvPr/>
        </p:nvCxnSpPr>
        <p:spPr>
          <a:xfrm>
            <a:off x="1843381" y="50288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3812420" y="49905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직선 연결선 98"/>
          <p:cNvCxnSpPr/>
          <p:nvPr/>
        </p:nvCxnSpPr>
        <p:spPr>
          <a:xfrm>
            <a:off x="3976981" y="50288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4669670" y="49905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4834231" y="50288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 rot="16200000">
            <a:off x="2742980" y="3414297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err="1" smtClean="0">
                <a:latin typeface="Arial" pitchFamily="34" charset="0"/>
                <a:cs typeface="Arial" pitchFamily="34" charset="0"/>
              </a:rPr>
              <a:t>sT</a:t>
            </a:r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-219295" y="5843172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HRAS</a:t>
            </a:r>
            <a:r>
              <a:rPr lang="en-US" altLang="ko-KR" sz="800" b="1" i="1" baseline="30000" dirty="0" smtClean="0">
                <a:latin typeface="Arial" pitchFamily="34" charset="0"/>
                <a:cs typeface="Arial" pitchFamily="34" charset="0"/>
              </a:rPr>
              <a:t>v12</a:t>
            </a:r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821570" y="740990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연결선 107"/>
          <p:cNvCxnSpPr/>
          <p:nvPr/>
        </p:nvCxnSpPr>
        <p:spPr>
          <a:xfrm>
            <a:off x="986131" y="744815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1678820" y="740990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직선 연결선 110"/>
          <p:cNvCxnSpPr/>
          <p:nvPr/>
        </p:nvCxnSpPr>
        <p:spPr>
          <a:xfrm>
            <a:off x="1843381" y="744815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70411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5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-7828" y="368800"/>
            <a:ext cx="311833" cy="204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59154" tIns="179577" rIns="359154" bIns="179577"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직사각형 88"/>
          <p:cNvSpPr/>
          <p:nvPr/>
        </p:nvSpPr>
        <p:spPr>
          <a:xfrm>
            <a:off x="4384000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직사각형 89"/>
          <p:cNvSpPr/>
          <p:nvPr/>
        </p:nvSpPr>
        <p:spPr>
          <a:xfrm>
            <a:off x="4644024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직사각형 90"/>
          <p:cNvSpPr/>
          <p:nvPr/>
        </p:nvSpPr>
        <p:spPr>
          <a:xfrm>
            <a:off x="4119819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acZ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직사각형 91"/>
          <p:cNvSpPr/>
          <p:nvPr/>
        </p:nvSpPr>
        <p:spPr>
          <a:xfrm>
            <a:off x="6106132" y="164867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IPO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직사각형 92"/>
          <p:cNvSpPr/>
          <p:nvPr/>
        </p:nvSpPr>
        <p:spPr>
          <a:xfrm>
            <a:off x="6341623" y="1604227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4880155" y="164867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DM2&amp;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240749" y="1799585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직선 연결선 95"/>
          <p:cNvCxnSpPr/>
          <p:nvPr/>
        </p:nvCxnSpPr>
        <p:spPr>
          <a:xfrm>
            <a:off x="4379177" y="1828229"/>
            <a:ext cx="75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7" name="그림 96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6747" t="35847" b="14450"/>
          <a:stretch/>
        </p:blipFill>
        <p:spPr>
          <a:xfrm>
            <a:off x="3978275" y="584200"/>
            <a:ext cx="2750564" cy="523875"/>
          </a:xfrm>
          <a:prstGeom prst="rect">
            <a:avLst/>
          </a:prstGeom>
        </p:spPr>
      </p:pic>
      <p:pic>
        <p:nvPicPr>
          <p:cNvPr id="98" name="그림 97"/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75"/>
          <a:stretch/>
        </p:blipFill>
        <p:spPr>
          <a:xfrm>
            <a:off x="3978275" y="1216126"/>
            <a:ext cx="2750564" cy="372103"/>
          </a:xfrm>
          <a:prstGeom prst="rect">
            <a:avLst/>
          </a:prstGeom>
        </p:spPr>
      </p:pic>
      <p:sp>
        <p:nvSpPr>
          <p:cNvPr id="99" name="직사각형 98"/>
          <p:cNvSpPr/>
          <p:nvPr/>
        </p:nvSpPr>
        <p:spPr>
          <a:xfrm>
            <a:off x="3862644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BMSC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5384125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 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직사각형 100"/>
          <p:cNvSpPr/>
          <p:nvPr/>
        </p:nvSpPr>
        <p:spPr>
          <a:xfrm>
            <a:off x="5634624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직사각형 101"/>
          <p:cNvSpPr/>
          <p:nvPr/>
        </p:nvSpPr>
        <p:spPr>
          <a:xfrm>
            <a:off x="5119944" y="160090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acZ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직사각형 102"/>
          <p:cNvSpPr/>
          <p:nvPr/>
        </p:nvSpPr>
        <p:spPr>
          <a:xfrm>
            <a:off x="5861230" y="1648672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DM2&amp;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240874" y="1799585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연결선 107"/>
          <p:cNvCxnSpPr/>
          <p:nvPr/>
        </p:nvCxnSpPr>
        <p:spPr>
          <a:xfrm>
            <a:off x="5379302" y="1828229"/>
            <a:ext cx="75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이등변 삼각형 108"/>
          <p:cNvSpPr/>
          <p:nvPr/>
        </p:nvSpPr>
        <p:spPr>
          <a:xfrm rot="16200000">
            <a:off x="6780694" y="788126"/>
            <a:ext cx="36000" cy="36000"/>
          </a:xfrm>
          <a:prstGeom prst="triangle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ko-KR" altLang="en-US"/>
          </a:p>
        </p:txBody>
      </p:sp>
      <p:sp>
        <p:nvSpPr>
          <p:cNvPr id="111" name="TextBox 110"/>
          <p:cNvSpPr txBox="1"/>
          <p:nvPr/>
        </p:nvSpPr>
        <p:spPr>
          <a:xfrm>
            <a:off x="3053415" y="739397"/>
            <a:ext cx="158417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    anti-TP53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053415" y="1296112"/>
            <a:ext cx="158417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    anti-</a:t>
            </a:r>
            <a:r>
              <a:rPr lang="el-GR" altLang="ko-KR" sz="800" b="1" dirty="0">
                <a:latin typeface="Arial" pitchFamily="34" charset="0"/>
                <a:cs typeface="Arial" pitchFamily="34" charset="0"/>
              </a:rPr>
              <a:t> β</a:t>
            </a:r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-ACTIN 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직사각형 116"/>
          <p:cNvSpPr/>
          <p:nvPr/>
        </p:nvSpPr>
        <p:spPr>
          <a:xfrm>
            <a:off x="3160822" y="362450"/>
            <a:ext cx="311833" cy="2047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59154" tIns="179577" rIns="359154" bIns="179577" rtlCol="0" anchor="ctr"/>
          <a:lstStyle/>
          <a:p>
            <a:pPr algn="ctr"/>
            <a:r>
              <a:rPr lang="en-US" altLang="ko-KR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ko-KR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7"/>
          <a:srcRect l="6300"/>
          <a:stretch/>
        </p:blipFill>
        <p:spPr>
          <a:xfrm>
            <a:off x="488950" y="548542"/>
            <a:ext cx="2804797" cy="2255716"/>
          </a:xfrm>
          <a:prstGeom prst="rect">
            <a:avLst/>
          </a:prstGeom>
        </p:spPr>
      </p:pic>
      <p:sp>
        <p:nvSpPr>
          <p:cNvPr id="119" name="TextBox 118"/>
          <p:cNvSpPr txBox="1"/>
          <p:nvPr/>
        </p:nvSpPr>
        <p:spPr>
          <a:xfrm rot="16200000">
            <a:off x="-263745" y="1153697"/>
            <a:ext cx="1044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i="1" dirty="0" smtClean="0">
                <a:latin typeface="Arial" pitchFamily="34" charset="0"/>
                <a:cs typeface="Arial" pitchFamily="34" charset="0"/>
              </a:rPr>
              <a:t>TP53/HPRT1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RNA expression        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770770" y="2717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직선 연결선 121"/>
          <p:cNvCxnSpPr/>
          <p:nvPr/>
        </p:nvCxnSpPr>
        <p:spPr>
          <a:xfrm>
            <a:off x="935331" y="2755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1628020" y="2717252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직선 연결선 125"/>
          <p:cNvCxnSpPr/>
          <p:nvPr/>
        </p:nvCxnSpPr>
        <p:spPr>
          <a:xfrm>
            <a:off x="1792581" y="275550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22"/>
          <p:cNvSpPr txBox="1">
            <a:spLocks noChangeArrowheads="1"/>
          </p:cNvSpPr>
          <p:nvPr/>
        </p:nvSpPr>
        <p:spPr bwMode="auto">
          <a:xfrm>
            <a:off x="3882488" y="1067388"/>
            <a:ext cx="29342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0.12     0.09     0.05     0.10     0.06    0.18     0.07    0.20     0.06     025      2.80               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1454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6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97" r="22862" b="2748"/>
          <a:stretch/>
        </p:blipFill>
        <p:spPr>
          <a:xfrm>
            <a:off x="296000" y="511792"/>
            <a:ext cx="2196000" cy="1425709"/>
          </a:xfrm>
          <a:prstGeom prst="rect">
            <a:avLst/>
          </a:prstGeom>
        </p:spPr>
      </p:pic>
      <p:sp>
        <p:nvSpPr>
          <p:cNvPr id="28" name="직사각형 27"/>
          <p:cNvSpPr/>
          <p:nvPr/>
        </p:nvSpPr>
        <p:spPr>
          <a:xfrm>
            <a:off x="679479" y="185473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363719" y="1853519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acZ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992809" y="1853519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1306139" y="1903509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DM2&amp;CDK4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1695665" y="1902294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IPO</a:t>
            </a:r>
          </a:p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863B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2247629" y="548909"/>
            <a:ext cx="58522" cy="5852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TextBox 34"/>
          <p:cNvSpPr txBox="1"/>
          <p:nvPr/>
        </p:nvSpPr>
        <p:spPr>
          <a:xfrm>
            <a:off x="2240818" y="482740"/>
            <a:ext cx="9948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2247629" y="650104"/>
            <a:ext cx="58522" cy="585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/>
          <p:cNvSpPr txBox="1"/>
          <p:nvPr/>
        </p:nvSpPr>
        <p:spPr>
          <a:xfrm>
            <a:off x="2246918" y="590759"/>
            <a:ext cx="9948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501083" y="1011867"/>
            <a:ext cx="16974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</a:t>
            </a:r>
            <a:r>
              <a:rPr lang="en-US" altLang="ko-KR" sz="600" dirty="0" smtClean="0">
                <a:latin typeface="Arial" pitchFamily="34" charset="0"/>
                <a:cs typeface="Arial" pitchFamily="34" charset="0"/>
              </a:rPr>
              <a:t>                 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50              100               150 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-346885" y="1025984"/>
            <a:ext cx="1044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Living cells</a:t>
            </a:r>
          </a:p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(% 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LacZ</a:t>
            </a:r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)</a:t>
            </a:r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 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오른쪽 대괄호 39"/>
          <p:cNvSpPr/>
          <p:nvPr/>
        </p:nvSpPr>
        <p:spPr>
          <a:xfrm rot="16200000">
            <a:off x="751474" y="683527"/>
            <a:ext cx="45719" cy="288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1" name="오른쪽 대괄호 40"/>
          <p:cNvSpPr/>
          <p:nvPr/>
        </p:nvSpPr>
        <p:spPr>
          <a:xfrm rot="16200000">
            <a:off x="906650" y="428263"/>
            <a:ext cx="45719" cy="61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509520" y="666465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0.015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73296" y="570929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 smtClean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0.27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오른쪽 대괄호 45"/>
          <p:cNvSpPr/>
          <p:nvPr/>
        </p:nvSpPr>
        <p:spPr>
          <a:xfrm rot="16200000">
            <a:off x="1765970" y="449231"/>
            <a:ext cx="45719" cy="288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1510368" y="425345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&lt;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오른쪽 대괄호 47"/>
          <p:cNvSpPr/>
          <p:nvPr/>
        </p:nvSpPr>
        <p:spPr>
          <a:xfrm rot="16200000">
            <a:off x="1932522" y="157575"/>
            <a:ext cx="45719" cy="61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1022863" y="423986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&lt;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0.00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2032313" y="1843150"/>
            <a:ext cx="504056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P6</a:t>
            </a:r>
            <a:endParaRPr lang="ko-KR" altLang="en-US" sz="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오른쪽 대괄호 50"/>
          <p:cNvSpPr/>
          <p:nvPr/>
        </p:nvSpPr>
        <p:spPr>
          <a:xfrm rot="16200000">
            <a:off x="1270594" y="287231"/>
            <a:ext cx="45719" cy="612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1690064" y="297961"/>
            <a:ext cx="5368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cs typeface="Arial" pitchFamily="34" charset="0"/>
              </a:rPr>
              <a:t>&lt; 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0.00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05045" y="2037659"/>
            <a:ext cx="994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/>
          <p:cNvCxnSpPr/>
          <p:nvPr/>
        </p:nvCxnSpPr>
        <p:spPr>
          <a:xfrm>
            <a:off x="683881" y="208544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683881" y="208544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89956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7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72" r="26657" b="9752"/>
          <a:stretch/>
        </p:blipFill>
        <p:spPr>
          <a:xfrm>
            <a:off x="53747" y="520733"/>
            <a:ext cx="3255510" cy="34416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41" r="36181" b="10038"/>
          <a:stretch/>
        </p:blipFill>
        <p:spPr>
          <a:xfrm>
            <a:off x="3526971" y="531619"/>
            <a:ext cx="3276599" cy="343078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3748" y="531619"/>
            <a:ext cx="14369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H-LacZ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26290" y="531618"/>
            <a:ext cx="14369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H-MDM2&amp;CDK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6314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8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48" y="364520"/>
            <a:ext cx="2376264" cy="2057824"/>
          </a:xfrm>
          <a:prstGeom prst="rect">
            <a:avLst/>
          </a:prstGeom>
        </p:spPr>
      </p:pic>
      <p:sp>
        <p:nvSpPr>
          <p:cNvPr id="8" name="자유형 7"/>
          <p:cNvSpPr/>
          <p:nvPr/>
        </p:nvSpPr>
        <p:spPr>
          <a:xfrm>
            <a:off x="433870" y="492379"/>
            <a:ext cx="2016413" cy="899472"/>
          </a:xfrm>
          <a:custGeom>
            <a:avLst/>
            <a:gdLst>
              <a:gd name="connsiteX0" fmla="*/ 37702 w 2016413"/>
              <a:gd name="connsiteY0" fmla="*/ 468151 h 899472"/>
              <a:gd name="connsiteX1" fmla="*/ 63581 w 2016413"/>
              <a:gd name="connsiteY1" fmla="*/ 174853 h 899472"/>
              <a:gd name="connsiteX2" fmla="*/ 236110 w 2016413"/>
              <a:gd name="connsiteY2" fmla="*/ 2325 h 899472"/>
              <a:gd name="connsiteX3" fmla="*/ 883091 w 2016413"/>
              <a:gd name="connsiteY3" fmla="*/ 295623 h 899472"/>
              <a:gd name="connsiteX4" fmla="*/ 1452434 w 2016413"/>
              <a:gd name="connsiteY4" fmla="*/ 373261 h 899472"/>
              <a:gd name="connsiteX5" fmla="*/ 1780238 w 2016413"/>
              <a:gd name="connsiteY5" fmla="*/ 485404 h 899472"/>
              <a:gd name="connsiteX6" fmla="*/ 2013151 w 2016413"/>
              <a:gd name="connsiteY6" fmla="*/ 795955 h 899472"/>
              <a:gd name="connsiteX7" fmla="*/ 1607710 w 2016413"/>
              <a:gd name="connsiteY7" fmla="*/ 761449 h 899472"/>
              <a:gd name="connsiteX8" fmla="*/ 1271280 w 2016413"/>
              <a:gd name="connsiteY8" fmla="*/ 770076 h 899472"/>
              <a:gd name="connsiteX9" fmla="*/ 934849 w 2016413"/>
              <a:gd name="connsiteY9" fmla="*/ 899472 h 899472"/>
              <a:gd name="connsiteX10" fmla="*/ 563914 w 2016413"/>
              <a:gd name="connsiteY10" fmla="*/ 770076 h 899472"/>
              <a:gd name="connsiteX11" fmla="*/ 37702 w 2016413"/>
              <a:gd name="connsiteY11" fmla="*/ 468151 h 8994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016413" h="899472">
                <a:moveTo>
                  <a:pt x="37702" y="468151"/>
                </a:moveTo>
                <a:cubicBezTo>
                  <a:pt x="-45687" y="368947"/>
                  <a:pt x="30513" y="252491"/>
                  <a:pt x="63581" y="174853"/>
                </a:cubicBezTo>
                <a:cubicBezTo>
                  <a:pt x="96649" y="97215"/>
                  <a:pt x="99525" y="-17803"/>
                  <a:pt x="236110" y="2325"/>
                </a:cubicBezTo>
                <a:cubicBezTo>
                  <a:pt x="372695" y="22453"/>
                  <a:pt x="680370" y="233800"/>
                  <a:pt x="883091" y="295623"/>
                </a:cubicBezTo>
                <a:cubicBezTo>
                  <a:pt x="1085812" y="357446"/>
                  <a:pt x="1302910" y="341631"/>
                  <a:pt x="1452434" y="373261"/>
                </a:cubicBezTo>
                <a:cubicBezTo>
                  <a:pt x="1601958" y="404891"/>
                  <a:pt x="1686785" y="414955"/>
                  <a:pt x="1780238" y="485404"/>
                </a:cubicBezTo>
                <a:cubicBezTo>
                  <a:pt x="1873691" y="555853"/>
                  <a:pt x="2041906" y="749948"/>
                  <a:pt x="2013151" y="795955"/>
                </a:cubicBezTo>
                <a:cubicBezTo>
                  <a:pt x="1984396" y="841962"/>
                  <a:pt x="1731355" y="765762"/>
                  <a:pt x="1607710" y="761449"/>
                </a:cubicBezTo>
                <a:cubicBezTo>
                  <a:pt x="1484065" y="757136"/>
                  <a:pt x="1383424" y="747072"/>
                  <a:pt x="1271280" y="770076"/>
                </a:cubicBezTo>
                <a:cubicBezTo>
                  <a:pt x="1159137" y="793080"/>
                  <a:pt x="1052743" y="899472"/>
                  <a:pt x="934849" y="899472"/>
                </a:cubicBezTo>
                <a:cubicBezTo>
                  <a:pt x="816955" y="899472"/>
                  <a:pt x="710563" y="841963"/>
                  <a:pt x="563914" y="770076"/>
                </a:cubicBezTo>
                <a:cubicBezTo>
                  <a:pt x="417265" y="698189"/>
                  <a:pt x="121091" y="567355"/>
                  <a:pt x="37702" y="468151"/>
                </a:cubicBezTo>
                <a:close/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32440" y="2213824"/>
            <a:ext cx="2664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PO-863B</a:t>
            </a:r>
          </a:p>
        </p:txBody>
      </p:sp>
      <p:pic>
        <p:nvPicPr>
          <p:cNvPr id="10" name="Picture 9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203"/>
          <a:stretch/>
        </p:blipFill>
        <p:spPr bwMode="auto">
          <a:xfrm>
            <a:off x="2542235" y="460616"/>
            <a:ext cx="4192936" cy="107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2633802" y="1695960"/>
            <a:ext cx="36701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 profile</a:t>
            </a:r>
          </a:p>
          <a:p>
            <a:pPr fontAlgn="ctr"/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POX: 8,11, D2S1338: 30, D3S1358: 15,18, FGA: 23, D5S818: 12, CSF1PO: 12, D7S820: 7,9, D8S1179: 10,12, TH01: 6,7, vWA:17,18,</a:t>
            </a:r>
            <a:endParaRPr lang="ko-KR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13S317: 12, D16S539: 11,12, D18S51: 15, D19S433: 13,14,</a:t>
            </a:r>
            <a:endParaRPr lang="ko-KR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21S11: 30, </a:t>
            </a:r>
            <a:r>
              <a:rPr lang="en-US" altLang="ko-KR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elogenin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X,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41765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ko-KR" altLang="en-US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Figure 9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870"/>
          <a:stretch/>
        </p:blipFill>
        <p:spPr>
          <a:xfrm>
            <a:off x="87313" y="470662"/>
            <a:ext cx="3917950" cy="3813560"/>
          </a:xfrm>
          <a:prstGeom prst="rect">
            <a:avLst/>
          </a:prstGeom>
        </p:spPr>
      </p:pic>
      <p:sp>
        <p:nvSpPr>
          <p:cNvPr id="32" name="TextBox 22"/>
          <p:cNvSpPr txBox="1">
            <a:spLocks noChangeArrowheads="1"/>
          </p:cNvSpPr>
          <p:nvPr/>
        </p:nvSpPr>
        <p:spPr bwMode="auto">
          <a:xfrm>
            <a:off x="3357831" y="4115671"/>
            <a:ext cx="6208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400X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3432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17</TotalTime>
  <Words>464</Words>
  <Application>Microsoft Office PowerPoint</Application>
  <PresentationFormat>화면 슬라이드 쇼(4:3)</PresentationFormat>
  <Paragraphs>226</Paragraphs>
  <Slides>9</Slides>
  <Notes>9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2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u Jin Kim</dc:creator>
  <cp:lastModifiedBy>Yu Jin Kim</cp:lastModifiedBy>
  <cp:revision>2010</cp:revision>
  <dcterms:created xsi:type="dcterms:W3CDTF">2011-05-05T18:30:17Z</dcterms:created>
  <dcterms:modified xsi:type="dcterms:W3CDTF">2019-03-01T08:45:52Z</dcterms:modified>
</cp:coreProperties>
</file>